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64" d="100"/>
          <a:sy n="64" d="100"/>
        </p:scale>
        <p:origin x="677" y="3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5E52B-D65F-14DF-1B51-4BD46297C4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44D163-6302-19A4-4C5D-5C8513D663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96ADCB-3A7E-5B21-338F-824CC3FB9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7D21DC-BDA5-D67E-9049-C6BB63425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F92EBA-0660-D5B5-A0FA-B54668C62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8069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B8EE44-073C-2271-0629-B1A9ED213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B8CAD2-40D1-E790-C25C-24530E99F6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11AFCB-4899-1B2C-0A39-52413E4F5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20B3A-4E41-38F4-6C8E-DFF423219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355DBA-9427-593F-1BE1-5349D2260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9366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F38961-1B9D-5774-678B-B12AF8330A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4F0EB2-A695-B719-A575-16E2BA9251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0EFE6-34E5-5E00-A738-C138D4EDB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6F446-2B97-9974-5377-CBC93D9E8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F7C9F6-76A8-A3B2-A836-022653606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497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A552F2-00BC-2F31-99DD-DF96092BD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F04062-2D2D-552A-3848-D1D7892D83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08832-DA05-CAD1-BD6E-A31BCA52F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30CA5F-FB5D-3303-AB93-3C64BB492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5050CE-09A9-2475-18C4-63517260A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740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E917A-3924-EC66-F130-8D8046FE0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08B0F5-EBD5-2940-B0B6-93AF972DF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0F3254-2475-4F9C-E131-3A233858C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498307-7782-E169-4CB6-BE809A5D8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80DE64-4255-7EAD-20D7-A8133F764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5104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D6366-F8C4-16C7-66D8-0EE46E686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6F19FA-E65F-D462-F2F3-37354EF35B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F56580-4E1A-020B-3D5A-CE0F651A17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FC017C-4D2A-D556-196C-A7910AD5B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57806B-4663-5202-CCED-F0774ACC1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56A8B3-8371-96F1-FC3A-D3FBA55A0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36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50271-33EB-E250-C787-6018CE4AA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A04FBA-0B36-845D-1B0D-CAC565F94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C03AB8-DEAE-A9F0-C1DD-2149AFB49B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F9FC6E-EF85-4FC6-62CC-6044D8F3A2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5C6EB5-AB68-FB95-A800-74A3C144C9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3453C1-A289-805A-A5CB-A97A40B95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25783E-D065-5D46-E97D-C92FCF2AB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BD9F87-023E-4F23-9FE5-8DBD0BECF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0055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46578-A2FF-2007-783A-3C329A231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B75468-6FD9-97D2-2F72-8C9137111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238765-7A96-E213-F7A0-0552BB2FB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97DBB9-CFDD-ED4D-DA0D-29B5ACBFA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540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A58108-EACC-E620-E63B-D5B946F71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8587A8-AEBC-0958-BB2A-E7BB58F99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427407-5162-4398-2620-5D32412D2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8182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91CAD6-7485-3330-7DD9-8C7B2BA66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372359-DD05-A169-F607-DBD5C33B1F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B0977A-359A-4FA3-C317-B284E6BA00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577A69-3170-CB05-D10D-BB72DA135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C38DB7-8D41-DE38-59F0-5F600C874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20D13E-A49E-D310-B1A9-DF34E7D9E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555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2915D2-7742-12F4-45CC-F3DE3743B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17F8FB-61A4-F246-416B-2FAE29FBFE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096FC7-47E1-5663-D078-4A5FD9AC67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476C7E-D284-A802-96F7-E368774C44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613B03-ACCF-F230-0435-D1EB8B981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593812-C634-3EB0-D30B-2E1D5102F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9775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AA28F2-3864-387F-4931-B5943B6A7B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9199CB-D261-B28B-4361-ACC1D298C4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6DB80B-0DDA-56FD-9897-F4C7876A41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871D16-F0C8-433E-862D-52BB490A61ED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84B76-3A41-AB0E-6836-407A5BDFC6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8CA566-1373-96FA-0000-3F018FE7F0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95A6BF-0A19-42FF-A08F-A121926798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9762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tif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000-00000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l="-132" t="-3090" r="-606" b="-1065"/>
          <a:stretch/>
        </p:blipFill>
        <p:spPr bwMode="auto">
          <a:xfrm>
            <a:off x="141778" y="338730"/>
            <a:ext cx="4893034" cy="1939541"/>
          </a:xfrm>
          <a:prstGeom prst="rect">
            <a:avLst/>
          </a:prstGeom>
          <a:noFill/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000-00000C000000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rcRect l="-618" t="377" r="-827" b="656"/>
          <a:stretch/>
        </p:blipFill>
        <p:spPr>
          <a:xfrm>
            <a:off x="141778" y="2422733"/>
            <a:ext cx="4559028" cy="223871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000-00000E000000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rcRect l="4275" t="5532" r="46781" b="26369"/>
          <a:stretch/>
        </p:blipFill>
        <p:spPr>
          <a:xfrm>
            <a:off x="5841477" y="1231419"/>
            <a:ext cx="3847271" cy="310417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0000000-0008-0000-0000-000015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/>
          <a:srcRect l="-103" t="87" r="-637" b="12"/>
          <a:stretch/>
        </p:blipFill>
        <p:spPr>
          <a:xfrm>
            <a:off x="141778" y="4787509"/>
            <a:ext cx="5546205" cy="200389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000-000019000000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841477" y="4474194"/>
            <a:ext cx="4010294" cy="231721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7A24002-C932-2BCB-CD01-4154D1ED2144}"/>
              </a:ext>
            </a:extLst>
          </p:cNvPr>
          <p:cNvSpPr txBox="1"/>
          <p:nvPr/>
        </p:nvSpPr>
        <p:spPr>
          <a:xfrm>
            <a:off x="107004" y="61731"/>
            <a:ext cx="19708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DLD1_biological repeat_n1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1DBD0E7-AC8A-D22F-88FE-BAA507F86933}"/>
              </a:ext>
            </a:extLst>
          </p:cNvPr>
          <p:cNvSpPr/>
          <p:nvPr/>
        </p:nvSpPr>
        <p:spPr>
          <a:xfrm>
            <a:off x="612843" y="5554494"/>
            <a:ext cx="1984442" cy="23346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1E4724A-D468-1D6B-C611-AD46A80DB41B}"/>
              </a:ext>
            </a:extLst>
          </p:cNvPr>
          <p:cNvSpPr/>
          <p:nvPr/>
        </p:nvSpPr>
        <p:spPr>
          <a:xfrm>
            <a:off x="436850" y="3045256"/>
            <a:ext cx="1712963" cy="23346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E6FDE6F-C955-F742-44FE-EA9E96EFA4A7}"/>
              </a:ext>
            </a:extLst>
          </p:cNvPr>
          <p:cNvSpPr/>
          <p:nvPr/>
        </p:nvSpPr>
        <p:spPr>
          <a:xfrm>
            <a:off x="708329" y="952023"/>
            <a:ext cx="1712963" cy="23346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18A3F1A-2BCA-5DDA-B793-2F8B5A79B5B0}"/>
              </a:ext>
            </a:extLst>
          </p:cNvPr>
          <p:cNvSpPr/>
          <p:nvPr/>
        </p:nvSpPr>
        <p:spPr>
          <a:xfrm>
            <a:off x="6493939" y="3657601"/>
            <a:ext cx="2825159" cy="30854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BBB08D6-767B-05CB-D1D1-DCE38A992492}"/>
              </a:ext>
            </a:extLst>
          </p:cNvPr>
          <p:cNvSpPr/>
          <p:nvPr/>
        </p:nvSpPr>
        <p:spPr>
          <a:xfrm>
            <a:off x="6410527" y="5145932"/>
            <a:ext cx="1391056" cy="23720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6A409DA-1AC4-C463-0F32-62746B004909}"/>
              </a:ext>
            </a:extLst>
          </p:cNvPr>
          <p:cNvSpPr txBox="1"/>
          <p:nvPr/>
        </p:nvSpPr>
        <p:spPr>
          <a:xfrm>
            <a:off x="2559992" y="954420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LMP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F29688-5000-55A2-683D-255D50118434}"/>
              </a:ext>
            </a:extLst>
          </p:cNvPr>
          <p:cNvSpPr txBox="1"/>
          <p:nvPr/>
        </p:nvSpPr>
        <p:spPr>
          <a:xfrm>
            <a:off x="2166791" y="3023487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LMP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31F5D0-2001-0C1F-9AF4-874A14F33212}"/>
              </a:ext>
            </a:extLst>
          </p:cNvPr>
          <p:cNvSpPr txBox="1"/>
          <p:nvPr/>
        </p:nvSpPr>
        <p:spPr>
          <a:xfrm>
            <a:off x="2601554" y="5528120"/>
            <a:ext cx="512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TAP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3EA4EC-3EAB-15A0-51A8-8948FB9D470E}"/>
              </a:ext>
            </a:extLst>
          </p:cNvPr>
          <p:cNvSpPr txBox="1"/>
          <p:nvPr/>
        </p:nvSpPr>
        <p:spPr>
          <a:xfrm>
            <a:off x="9339130" y="3673371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07D2034-2D61-93D9-5460-47C8A0F64B01}"/>
              </a:ext>
            </a:extLst>
          </p:cNvPr>
          <p:cNvSpPr txBox="1"/>
          <p:nvPr/>
        </p:nvSpPr>
        <p:spPr>
          <a:xfrm>
            <a:off x="7906518" y="5113120"/>
            <a:ext cx="62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HIF-1</a:t>
            </a:r>
            <a:r>
              <a:rPr lang="el-GR" sz="1200" dirty="0">
                <a:solidFill>
                  <a:srgbClr val="FF0000"/>
                </a:solidFill>
              </a:rPr>
              <a:t>α</a:t>
            </a:r>
            <a:endParaRPr lang="en-GB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14999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46F448B-B2D9-5682-7112-CF08F30AD7FE}"/>
              </a:ext>
            </a:extLst>
          </p:cNvPr>
          <p:cNvSpPr txBox="1"/>
          <p:nvPr/>
        </p:nvSpPr>
        <p:spPr>
          <a:xfrm>
            <a:off x="107004" y="61731"/>
            <a:ext cx="19708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DLD1_biological repeat_n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000-00000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b="-340"/>
          <a:stretch/>
        </p:blipFill>
        <p:spPr bwMode="auto">
          <a:xfrm>
            <a:off x="107004" y="447219"/>
            <a:ext cx="5505449" cy="3175635"/>
          </a:xfrm>
          <a:prstGeom prst="rect">
            <a:avLst/>
          </a:prstGeom>
          <a:noFill/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000-00000C000000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rcRect b="-334"/>
          <a:stretch/>
        </p:blipFill>
        <p:spPr>
          <a:xfrm>
            <a:off x="107003" y="3731343"/>
            <a:ext cx="5505449" cy="317563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000-000016000000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rcRect l="289" t="-460" r="-289" b="683"/>
          <a:stretch/>
        </p:blipFill>
        <p:spPr>
          <a:xfrm>
            <a:off x="6351932" y="3682366"/>
            <a:ext cx="5505449" cy="317563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000-00001C000000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351932" y="447220"/>
            <a:ext cx="5505450" cy="317563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3274C95F-3FC1-BC51-B725-CCF91015E8A3}"/>
              </a:ext>
            </a:extLst>
          </p:cNvPr>
          <p:cNvSpPr/>
          <p:nvPr/>
        </p:nvSpPr>
        <p:spPr>
          <a:xfrm>
            <a:off x="364902" y="2140743"/>
            <a:ext cx="1712963" cy="23346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63D009-EB63-01BD-8F56-2305C6841561}"/>
              </a:ext>
            </a:extLst>
          </p:cNvPr>
          <p:cNvSpPr txBox="1"/>
          <p:nvPr/>
        </p:nvSpPr>
        <p:spPr>
          <a:xfrm>
            <a:off x="2077865" y="2118974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LMP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7020BB-0532-F58F-815A-EF1D25770C08}"/>
              </a:ext>
            </a:extLst>
          </p:cNvPr>
          <p:cNvSpPr txBox="1"/>
          <p:nvPr/>
        </p:nvSpPr>
        <p:spPr>
          <a:xfrm>
            <a:off x="2747882" y="5389620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LMP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24523D-0BC1-301C-921C-A276120B2FFE}"/>
              </a:ext>
            </a:extLst>
          </p:cNvPr>
          <p:cNvSpPr txBox="1"/>
          <p:nvPr/>
        </p:nvSpPr>
        <p:spPr>
          <a:xfrm>
            <a:off x="9104656" y="5016640"/>
            <a:ext cx="512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TAP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C2FA6E2-663D-7F7E-7672-7ED44DA2F391}"/>
              </a:ext>
            </a:extLst>
          </p:cNvPr>
          <p:cNvSpPr/>
          <p:nvPr/>
        </p:nvSpPr>
        <p:spPr>
          <a:xfrm>
            <a:off x="594104" y="5316378"/>
            <a:ext cx="1943356" cy="35024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7DC12A7-6011-9C12-A4F0-D9C4762A8D1E}"/>
              </a:ext>
            </a:extLst>
          </p:cNvPr>
          <p:cNvSpPr/>
          <p:nvPr/>
        </p:nvSpPr>
        <p:spPr>
          <a:xfrm>
            <a:off x="6818852" y="4946720"/>
            <a:ext cx="2055260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626BEF4-69D9-D9F7-714A-E7471C8232E2}"/>
              </a:ext>
            </a:extLst>
          </p:cNvPr>
          <p:cNvSpPr/>
          <p:nvPr/>
        </p:nvSpPr>
        <p:spPr>
          <a:xfrm>
            <a:off x="6731222" y="2414232"/>
            <a:ext cx="1753648" cy="35182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0000000-0008-0000-0000-000029000000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rcRect l="3633" r="49481"/>
          <a:stretch>
            <a:fillRect/>
          </a:stretch>
        </p:blipFill>
        <p:spPr>
          <a:xfrm>
            <a:off x="9224349" y="444859"/>
            <a:ext cx="2581275" cy="3175635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9C7641E0-043E-2E50-E0F6-2EED87E5C9AB}"/>
              </a:ext>
            </a:extLst>
          </p:cNvPr>
          <p:cNvSpPr/>
          <p:nvPr/>
        </p:nvSpPr>
        <p:spPr>
          <a:xfrm>
            <a:off x="9754076" y="3017520"/>
            <a:ext cx="2051548" cy="33147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0CEE35-DBA3-FDD3-DE35-281E6A0D76E6}"/>
              </a:ext>
            </a:extLst>
          </p:cNvPr>
          <p:cNvSpPr txBox="1"/>
          <p:nvPr/>
        </p:nvSpPr>
        <p:spPr>
          <a:xfrm>
            <a:off x="9057164" y="3071991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33CFB49-2F1B-68F5-6242-C312F260B358}"/>
              </a:ext>
            </a:extLst>
          </p:cNvPr>
          <p:cNvSpPr txBox="1"/>
          <p:nvPr/>
        </p:nvSpPr>
        <p:spPr>
          <a:xfrm>
            <a:off x="8433595" y="2451646"/>
            <a:ext cx="62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HIF-1</a:t>
            </a:r>
            <a:r>
              <a:rPr lang="el-GR" sz="1200" dirty="0">
                <a:solidFill>
                  <a:srgbClr val="FF0000"/>
                </a:solidFill>
              </a:rPr>
              <a:t>α</a:t>
            </a:r>
            <a:endParaRPr lang="en-GB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82060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&#10;&#10;Description automatically generated">
            <a:extLst>
              <a:ext uri="{FF2B5EF4-FFF2-40B4-BE49-F238E27FC236}">
                <a16:creationId xmlns:a16="http://schemas.microsoft.com/office/drawing/2014/main" id="{E6287ECE-2D09-2033-A482-AD2669992F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6203" y="403926"/>
            <a:ext cx="5040110" cy="3025076"/>
          </a:xfrm>
          <a:prstGeom prst="rect">
            <a:avLst/>
          </a:prstGeom>
        </p:spPr>
      </p:pic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6DC0F8DE-28EC-E0FD-7F0E-50085835B9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6203" y="3585636"/>
            <a:ext cx="5040110" cy="3025076"/>
          </a:xfrm>
          <a:prstGeom prst="rect">
            <a:avLst/>
          </a:prstGeom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DAC2CDCA-C332-2034-B497-718F2957AA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87" y="403925"/>
            <a:ext cx="5040109" cy="3025076"/>
          </a:xfrm>
          <a:prstGeom prst="rect">
            <a:avLst/>
          </a:prstGeom>
        </p:spPr>
      </p:pic>
      <p:pic>
        <p:nvPicPr>
          <p:cNvPr id="9" name="Picture 8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9E8719A3-0F01-1B90-1FE4-50D3E24F663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004" y="3585636"/>
            <a:ext cx="5040110" cy="302507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92F31A5-CE5A-23F2-9C4D-A80057439DC6}"/>
              </a:ext>
            </a:extLst>
          </p:cNvPr>
          <p:cNvSpPr txBox="1"/>
          <p:nvPr/>
        </p:nvSpPr>
        <p:spPr>
          <a:xfrm>
            <a:off x="107004" y="61731"/>
            <a:ext cx="19708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DLD1_biological repeat_n3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825686B-333B-9D67-CCC0-662FAF890F45}"/>
              </a:ext>
            </a:extLst>
          </p:cNvPr>
          <p:cNvSpPr/>
          <p:nvPr/>
        </p:nvSpPr>
        <p:spPr>
          <a:xfrm>
            <a:off x="5963527" y="1710500"/>
            <a:ext cx="1877453" cy="25983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DFE5427-8DAB-3309-C6B7-D6B27220AB39}"/>
              </a:ext>
            </a:extLst>
          </p:cNvPr>
          <p:cNvSpPr/>
          <p:nvPr/>
        </p:nvSpPr>
        <p:spPr>
          <a:xfrm>
            <a:off x="235451" y="5069983"/>
            <a:ext cx="1712963" cy="20797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D7E4729-DA9C-4221-882E-EA897685CCA1}"/>
              </a:ext>
            </a:extLst>
          </p:cNvPr>
          <p:cNvSpPr/>
          <p:nvPr/>
        </p:nvSpPr>
        <p:spPr>
          <a:xfrm>
            <a:off x="477833" y="2124364"/>
            <a:ext cx="1840494" cy="20628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019B0E1-0939-F9AE-0B04-E9424C821F38}"/>
              </a:ext>
            </a:extLst>
          </p:cNvPr>
          <p:cNvSpPr/>
          <p:nvPr/>
        </p:nvSpPr>
        <p:spPr>
          <a:xfrm>
            <a:off x="6096000" y="5246710"/>
            <a:ext cx="1923789" cy="2769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76C8014-6854-8A05-FA33-493FE87D8801}"/>
              </a:ext>
            </a:extLst>
          </p:cNvPr>
          <p:cNvSpPr/>
          <p:nvPr/>
        </p:nvSpPr>
        <p:spPr>
          <a:xfrm>
            <a:off x="6141720" y="4561350"/>
            <a:ext cx="1810518" cy="30854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9A68D1-D13E-2548-18A9-086FEBA790E4}"/>
              </a:ext>
            </a:extLst>
          </p:cNvPr>
          <p:cNvSpPr txBox="1"/>
          <p:nvPr/>
        </p:nvSpPr>
        <p:spPr>
          <a:xfrm>
            <a:off x="2432994" y="2089006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LMP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2275B80-09C3-5D8C-914A-1121618B3AB1}"/>
              </a:ext>
            </a:extLst>
          </p:cNvPr>
          <p:cNvSpPr txBox="1"/>
          <p:nvPr/>
        </p:nvSpPr>
        <p:spPr>
          <a:xfrm>
            <a:off x="1914118" y="5022721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LMP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D18577-7227-6C72-2365-069BBB10349E}"/>
              </a:ext>
            </a:extLst>
          </p:cNvPr>
          <p:cNvSpPr txBox="1"/>
          <p:nvPr/>
        </p:nvSpPr>
        <p:spPr>
          <a:xfrm>
            <a:off x="8019789" y="1710500"/>
            <a:ext cx="512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TAP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F9F8B51-1DE6-1E44-96C6-E3EEF64AE943}"/>
              </a:ext>
            </a:extLst>
          </p:cNvPr>
          <p:cNvSpPr txBox="1"/>
          <p:nvPr/>
        </p:nvSpPr>
        <p:spPr>
          <a:xfrm>
            <a:off x="8019789" y="5246710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CAB5465-9241-FBF4-2C36-091C4FDF375A}"/>
              </a:ext>
            </a:extLst>
          </p:cNvPr>
          <p:cNvSpPr txBox="1"/>
          <p:nvPr/>
        </p:nvSpPr>
        <p:spPr>
          <a:xfrm>
            <a:off x="8019789" y="4577120"/>
            <a:ext cx="62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HIF-1</a:t>
            </a:r>
            <a:r>
              <a:rPr lang="el-GR" sz="1200" dirty="0">
                <a:solidFill>
                  <a:srgbClr val="FF0000"/>
                </a:solidFill>
              </a:rPr>
              <a:t>α</a:t>
            </a:r>
            <a:endParaRPr lang="en-GB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837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9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4</cp:revision>
  <dcterms:created xsi:type="dcterms:W3CDTF">2024-09-01T08:56:13Z</dcterms:created>
  <dcterms:modified xsi:type="dcterms:W3CDTF">2024-09-01T09:25:21Z</dcterms:modified>
</cp:coreProperties>
</file>